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D3648E-E6C8-4C7A-A316-F0585690AE9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829765-E2B4-4F14-833A-820D70A599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A29006-F1EB-4E00-B682-7659FF7B81D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4EDA6E-6815-4D0A-9654-848EB484E8A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45AAC4-A04C-45F8-94E3-E88F8489F21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42E52-251F-47A3-A500-75D9CD87E1C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AC135F-D5BD-46DA-91B9-78B392FF52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9AE5E2-50AD-49B6-A154-D9B7958DD4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067888-294A-4C0E-A01D-87CFC8BD8E1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C49566-0612-4FA5-B5AF-5852331E59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59DA2C-77B7-4F5E-A971-25F772DAB3B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3FB93C-22B1-4269-A3EC-7082596C95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5F7AED0-7112-47EE-A8BE-A32EE0A7765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5"/>
          <p:cNvSpPr/>
          <p:nvPr/>
        </p:nvSpPr>
        <p:spPr>
          <a:xfrm>
            <a:off x="914400" y="836640"/>
            <a:ext cx="3048120" cy="657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otentially relevant studies identified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n=56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-2858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EDLINE (n=51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-2858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linical trial registries (n=1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-2858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cientific conference proceedings (n=4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 Box 7"/>
          <p:cNvSpPr/>
          <p:nvPr/>
        </p:nvSpPr>
        <p:spPr>
          <a:xfrm>
            <a:off x="914400" y="2556000"/>
            <a:ext cx="3048120" cy="335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1440" bIns="9144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CT’s retrieved for detailed evaluation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n=26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13"/>
          <p:cNvSpPr/>
          <p:nvPr/>
        </p:nvSpPr>
        <p:spPr>
          <a:xfrm>
            <a:off x="3048120" y="3030480"/>
            <a:ext cx="2590560" cy="6577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tudies excluded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n=5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-2858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rong study population (n=1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-2858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rong outcome (n=1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-2858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Wrong comparison (n=3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 Box 14"/>
          <p:cNvSpPr/>
          <p:nvPr/>
        </p:nvSpPr>
        <p:spPr>
          <a:xfrm>
            <a:off x="914400" y="3995640"/>
            <a:ext cx="3048120" cy="398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Aft>
                <a:spcPts val="51"/>
              </a:spcAft>
              <a:tabLst>
                <a:tab algn="l" pos="0"/>
                <a:tab algn="l" pos="114480"/>
                <a:tab algn="l" pos="228600"/>
                <a:tab algn="l" pos="343080"/>
                <a:tab algn="l" pos="457200"/>
                <a:tab algn="l" pos="571680"/>
                <a:tab algn="l" pos="685800"/>
                <a:tab algn="l" pos="800280"/>
                <a:tab algn="l" pos="914400"/>
                <a:tab algn="l" pos="1028880"/>
                <a:tab algn="l" pos="1143000"/>
                <a:tab algn="l" pos="1257480"/>
                <a:tab algn="l" pos="1371600"/>
                <a:tab algn="l" pos="1486080"/>
                <a:tab algn="l" pos="1600200"/>
                <a:tab algn="l" pos="1714680"/>
                <a:tab algn="l" pos="1828800"/>
                <a:tab algn="l" pos="1943280"/>
                <a:tab algn="l" pos="2057400"/>
                <a:tab algn="l" pos="2171880"/>
                <a:tab algn="l" pos="2286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Potentially appropriate RCT’s to be included in meta-analysis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n=21)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17"/>
          <p:cNvSpPr/>
          <p:nvPr/>
        </p:nvSpPr>
        <p:spPr>
          <a:xfrm>
            <a:off x="3048120" y="1627200"/>
            <a:ext cx="2590560" cy="5205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171360" indent="-17136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tudies excluded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n=30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marL="171360" indent="-17136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Non-RCT (n=26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marL="171360" indent="-171360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	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ifferent Outcome of Interest (n=4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22"/>
          <p:cNvSpPr/>
          <p:nvPr/>
        </p:nvSpPr>
        <p:spPr>
          <a:xfrm>
            <a:off x="3048120" y="4933800"/>
            <a:ext cx="2590560" cy="3834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CT’s excluded from meta-analysi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lvl="1" marL="457200" indent="-285840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Unpublished abstract (n=1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24"/>
          <p:cNvSpPr/>
          <p:nvPr/>
        </p:nvSpPr>
        <p:spPr>
          <a:xfrm>
            <a:off x="914400" y="5680080"/>
            <a:ext cx="3048120" cy="1480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RCT’s included in meta-analysis 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(n=20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i="1" lang="en-US" sz="900" spc="-1" strike="noStrike">
                <a:solidFill>
                  <a:srgbClr val="000000"/>
                </a:solidFill>
                <a:latin typeface="Arial"/>
              </a:rPr>
              <a:t>Unique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Studies (n=16*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Studies in each comparison group **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osiglitazone vs. Placebo or no treatment (n=9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Pioglitazone vs. Placebo (n=2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Metformin vs. Placebo or no treatment (n=6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          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Rosiglitazone vs. Metformin (n=3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*     4 studies yielded two publications each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**   Some studies included multiple comparison arm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48" name="AutoShape 27"/>
          <p:cNvCxnSpPr>
            <a:endCxn id="42" idx="0"/>
          </p:cNvCxnSpPr>
          <p:nvPr/>
        </p:nvCxnSpPr>
        <p:spPr>
          <a:xfrm>
            <a:off x="2437920" y="1499760"/>
            <a:ext cx="720" cy="105660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49" name="AutoShape 28"/>
          <p:cNvCxnSpPr>
            <a:stCxn id="42" idx="2"/>
            <a:endCxn id="44" idx="0"/>
          </p:cNvCxnSpPr>
          <p:nvPr/>
        </p:nvCxnSpPr>
        <p:spPr>
          <a:xfrm>
            <a:off x="2438280" y="2891520"/>
            <a:ext cx="360" cy="11044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0" name="AutoShape 29"/>
          <p:cNvCxnSpPr>
            <a:stCxn id="44" idx="2"/>
            <a:endCxn id="47" idx="0"/>
          </p:cNvCxnSpPr>
          <p:nvPr/>
        </p:nvCxnSpPr>
        <p:spPr>
          <a:xfrm>
            <a:off x="2438280" y="4394160"/>
            <a:ext cx="360" cy="12862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1" name="AutoShape 35"/>
          <p:cNvCxnSpPr>
            <a:endCxn id="45" idx="1"/>
          </p:cNvCxnSpPr>
          <p:nvPr/>
        </p:nvCxnSpPr>
        <p:spPr>
          <a:xfrm flipV="1">
            <a:off x="2438280" y="1887480"/>
            <a:ext cx="610200" cy="32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2" name="AutoShape 36"/>
          <p:cNvCxnSpPr>
            <a:endCxn id="43" idx="1"/>
          </p:cNvCxnSpPr>
          <p:nvPr/>
        </p:nvCxnSpPr>
        <p:spPr>
          <a:xfrm flipV="1">
            <a:off x="2438280" y="3359160"/>
            <a:ext cx="610200" cy="324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3" name="AutoShape 37"/>
          <p:cNvCxnSpPr>
            <a:endCxn id="46" idx="1"/>
          </p:cNvCxnSpPr>
          <p:nvPr/>
        </p:nvCxnSpPr>
        <p:spPr>
          <a:xfrm flipV="1">
            <a:off x="2438280" y="5125320"/>
            <a:ext cx="61020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7-30T17:07:41Z</dcterms:created>
  <dc:creator> </dc:creator>
  <dc:description/>
  <dc:language>en-US</dc:language>
  <cp:lastModifiedBy>Sid Sheth </cp:lastModifiedBy>
  <dcterms:modified xsi:type="dcterms:W3CDTF">2010-04-28T20:19:44Z</dcterms:modified>
  <cp:revision>66</cp:revision>
  <dc:subject/>
  <dc:title>Slide 1</dc:title>
</cp:coreProperties>
</file>